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&amp;Fede" initials="A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C000"/>
    <a:srgbClr val="BC3C29"/>
    <a:srgbClr val="4472C4"/>
    <a:srgbClr val="D78B7F"/>
    <a:srgbClr val="0070C1"/>
    <a:srgbClr val="909090"/>
    <a:srgbClr val="EEBB00"/>
    <a:srgbClr val="FF8000"/>
    <a:srgbClr val="0000FF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786" autoAdjust="0"/>
    <p:restoredTop sz="94626"/>
  </p:normalViewPr>
  <p:slideViewPr>
    <p:cSldViewPr snapToGrid="0">
      <p:cViewPr varScale="1">
        <p:scale>
          <a:sx n="115" d="100"/>
          <a:sy n="115" d="100"/>
        </p:scale>
        <p:origin x="26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FB83E-C48E-447E-9B3B-133D6A49D7EE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49B13-6FF4-4488-95DA-3919E18726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95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Inserire VAF TP53 ut?</a:t>
            </a: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F49B13-6FF4-4488-95DA-3919E187264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50356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A63C0C-5577-4C4F-61B3-CAFB1235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A603D7D-CEDD-0E8C-733F-1419457099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35D4-5E28-43CC-4258-10D5F57B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8FB44-08E5-DC01-F286-00A4B70CA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D877C2-5464-507D-9398-03A3954C4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9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55BF24-0E63-E15D-0FB7-6DED958D6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F4C177-79C7-F108-008D-55C2DB706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4BE381-0992-F1D1-47A1-D82412118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067EC9-B9E8-9182-06AE-3D28BFF9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D62368-E692-E3D8-85A8-A9760E77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67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B6A7F61-ACE5-5156-1B30-49C52B4F7D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801A64-95FE-B96E-B84E-D892265F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693709-87BF-F58D-A0C8-091B34C1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CD796-6F33-DF2E-3351-C9A261969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CB49C7-3337-9EE1-CC4B-A57EE1D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80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34808E-2EBC-C139-9D9D-4BD441DA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B8B1B5-AF78-546E-1B4F-3B72E71BC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A1BC50-4AFE-3E13-8410-C351AA72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9C010-CE3B-EEDC-B29C-F358AAD8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0AB1A3-863D-D8AE-A5C2-4506665F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70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ECB986-6728-CA75-D17B-453452C00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04A5FD-A86A-D366-A583-981DE08834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B1E49-EAB1-E1AB-FA38-F86BAFE38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B0A145-6BA2-FFE0-05CC-06367F3F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737D9-BE9B-7F61-C270-66ADD4B6E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596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DA176-9AEF-86A0-F853-93C569731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C949C-DECD-3F5C-9081-E837876ED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ADA58F-20A5-8915-5085-F6E80775AC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725F3F-94E5-3B09-4810-6F8AB0076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50594C-1CE5-043C-1F64-D8D77BF7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6FF6CC-5708-74BF-ED94-E3E857F3E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14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2884-E46C-7B85-42C6-0100C1ABF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0A09C-C24B-1866-FC96-B9F4C7E9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1F5CB0-6543-A984-7EF7-7815646F1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6EB3B6-1505-4468-6143-C658F31EBF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C82EC3-B6CF-B4F8-A541-245CBF0EB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5D12E8C-B186-5A7E-BDB9-6EDEAE98E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EB10F3A-2B17-3E0C-5B31-371A9444A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9D86D7-A67F-BC78-13A0-B8225D41D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17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862856-CEAD-F763-03ED-ADAFCB54A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B020A37-17B0-BDCD-E5E9-EED476A7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08FC7F-14D6-FBEC-16B3-392247F5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60DF6CA-D338-828B-87C9-16AE0A244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37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4D705D-6731-3F07-784A-21C53817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681606-DC1A-7757-FB04-1591E3AC4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6483D9F-9708-6D4A-35CA-7F78CBC4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5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FB8B3C-31B6-5DA6-3C01-C47FF05C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3FECB9-35C2-12D2-C0CD-1E2FEDB41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BD989E8-83D8-8F0F-A3BF-2BEC740C5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A96B903-B458-252B-17FA-3B4F6A23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EDD6C9-0DE3-A03D-4B8D-AC2A27404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2D31-AA36-9F61-447A-01421E7B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169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3A27E8-DF0C-AC6A-5538-C06A86CD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EAAA7EB-851F-32CC-D3EB-8C30D2AA7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FEA5DBA-8946-549E-49FF-A963F8924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D64142-E4FE-4056-6459-99012726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E2D54-7485-9ED6-5B32-EDC22F6FC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6305A-BC26-554B-6728-9DFD3DE39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2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E6D9B43-DA48-B1BD-F6A8-DEF111A7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41DCF3-5DF7-90C3-3022-EE4630C32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337486-CF24-BF87-82A2-D50C982582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E592BA-4B9A-BC56-5D65-520F78FDF8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412DB8-AEFC-A7A2-C09A-EE8DD88FBF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1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12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5" Type="http://schemas.openxmlformats.org/officeDocument/2006/relationships/image" Target="../media/image2.png"/><Relationship Id="rId10" Type="http://schemas.openxmlformats.org/officeDocument/2006/relationships/image" Target="../media/image6.png"/><Relationship Id="rId4" Type="http://schemas.openxmlformats.org/officeDocument/2006/relationships/image" Target="../media/image1.emf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30BF6771-B5A4-E459-C572-C2C3ED02CAAA}"/>
              </a:ext>
            </a:extLst>
          </p:cNvPr>
          <p:cNvSpPr txBox="1"/>
          <p:nvPr/>
        </p:nvSpPr>
        <p:spPr>
          <a:xfrm>
            <a:off x="298411" y="322282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7A112E19-8F78-A46E-967C-FF9206F19D72}"/>
              </a:ext>
            </a:extLst>
          </p:cNvPr>
          <p:cNvSpPr txBox="1"/>
          <p:nvPr/>
        </p:nvSpPr>
        <p:spPr>
          <a:xfrm rot="16200000">
            <a:off x="-280162" y="1465345"/>
            <a:ext cx="17429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100" dirty="0"/>
              <a:t>Cumulative TP53 </a:t>
            </a:r>
            <a:r>
              <a:rPr lang="it-IT" sz="1100" dirty="0" err="1"/>
              <a:t>VAFs</a:t>
            </a:r>
            <a:r>
              <a:rPr lang="it-IT" sz="1100" dirty="0"/>
              <a:t> (%)</a:t>
            </a:r>
          </a:p>
        </p:txBody>
      </p:sp>
      <p:graphicFrame>
        <p:nvGraphicFramePr>
          <p:cNvPr id="12" name="Oggetto 11">
            <a:extLst>
              <a:ext uri="{FF2B5EF4-FFF2-40B4-BE49-F238E27FC236}">
                <a16:creationId xmlns:a16="http://schemas.microsoft.com/office/drawing/2014/main" id="{7FE0AEF7-D168-7B35-BA42-A3AB1DB0CDD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7852" y="551900"/>
          <a:ext cx="2127250" cy="1965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127330" imgH="1965750" progId="Prism9.Document">
                  <p:embed/>
                </p:oleObj>
              </mc:Choice>
              <mc:Fallback>
                <p:oleObj name="Prism 9" r:id="rId3" imgW="2127330" imgH="1965750" progId="Prism9.Document">
                  <p:embed/>
                  <p:pic>
                    <p:nvPicPr>
                      <p:cNvPr id="12" name="Oggetto 11">
                        <a:extLst>
                          <a:ext uri="{FF2B5EF4-FFF2-40B4-BE49-F238E27FC236}">
                            <a16:creationId xmlns:a16="http://schemas.microsoft.com/office/drawing/2014/main" id="{7FE0AEF7-D168-7B35-BA42-A3AB1DB0CD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7852" y="551900"/>
                        <a:ext cx="2127250" cy="1965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52DE2590-9CA5-5724-D5E5-F73494C985A2}"/>
              </a:ext>
            </a:extLst>
          </p:cNvPr>
          <p:cNvSpPr txBox="1"/>
          <p:nvPr/>
        </p:nvSpPr>
        <p:spPr>
          <a:xfrm>
            <a:off x="1297172" y="592621"/>
            <a:ext cx="526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i="1" dirty="0"/>
              <a:t>#3</a:t>
            </a: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C0163E41-7EF6-9073-4B23-0A060CA60EC3}"/>
              </a:ext>
            </a:extLst>
          </p:cNvPr>
          <p:cNvSpPr txBox="1"/>
          <p:nvPr/>
        </p:nvSpPr>
        <p:spPr>
          <a:xfrm>
            <a:off x="2116196" y="1090461"/>
            <a:ext cx="5264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i="1" dirty="0"/>
              <a:t>#2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A5EF896C-A226-F181-ACE0-64C178C43D68}"/>
              </a:ext>
            </a:extLst>
          </p:cNvPr>
          <p:cNvSpPr txBox="1"/>
          <p:nvPr/>
        </p:nvSpPr>
        <p:spPr>
          <a:xfrm rot="-2700000">
            <a:off x="1007142" y="2484661"/>
            <a:ext cx="5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/>
              <a:t>RMp#1</a:t>
            </a:r>
          </a:p>
          <a:p>
            <a:pPr algn="r"/>
            <a:r>
              <a:rPr lang="it-IT" sz="900" dirty="0"/>
              <a:t>(2010)</a:t>
            </a: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55F89EA1-3116-4E38-91E1-E496252B6608}"/>
              </a:ext>
            </a:extLst>
          </p:cNvPr>
          <p:cNvSpPr txBox="1"/>
          <p:nvPr/>
        </p:nvSpPr>
        <p:spPr>
          <a:xfrm rot="-2700000">
            <a:off x="1400122" y="2484663"/>
            <a:ext cx="5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/>
              <a:t>RMp#2</a:t>
            </a:r>
          </a:p>
          <a:p>
            <a:pPr algn="r"/>
            <a:r>
              <a:rPr lang="it-IT" sz="900" dirty="0"/>
              <a:t>(2012)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915DF9DF-01E8-5F4E-B1A1-A4FD2B9FE9D5}"/>
              </a:ext>
            </a:extLst>
          </p:cNvPr>
          <p:cNvSpPr txBox="1"/>
          <p:nvPr/>
        </p:nvSpPr>
        <p:spPr>
          <a:xfrm rot="-2700000">
            <a:off x="1944432" y="2484662"/>
            <a:ext cx="5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 err="1"/>
              <a:t>RMp</a:t>
            </a:r>
            <a:endParaRPr lang="it-IT" sz="900" dirty="0"/>
          </a:p>
          <a:p>
            <a:pPr algn="r"/>
            <a:r>
              <a:rPr lang="it-IT" sz="900" dirty="0"/>
              <a:t>(2015)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13B56732-DBEA-8C25-B0CC-47EC0D675700}"/>
              </a:ext>
            </a:extLst>
          </p:cNvPr>
          <p:cNvSpPr txBox="1"/>
          <p:nvPr/>
        </p:nvSpPr>
        <p:spPr>
          <a:xfrm rot="-2700000">
            <a:off x="2227176" y="2505083"/>
            <a:ext cx="575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900" dirty="0"/>
              <a:t>PEH</a:t>
            </a:r>
          </a:p>
          <a:p>
            <a:pPr algn="r"/>
            <a:r>
              <a:rPr lang="it-IT" sz="900" dirty="0"/>
              <a:t>(2019)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32D24E95-9E94-BF88-B667-9E7E606729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8817" y="729396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63A1CBF5-26FF-D35D-57E7-F32E76346B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50950" y="729396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C2371A56-A1F6-CD37-5A9F-51966589307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88818" y="1345422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6DF2B256-2E0E-B16C-BC33-C7C767C268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50950" y="1345422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D03CE662-CC9A-5622-8273-D3F75A5E1590}"/>
              </a:ext>
            </a:extLst>
          </p:cNvPr>
          <p:cNvSpPr txBox="1"/>
          <p:nvPr/>
        </p:nvSpPr>
        <p:spPr>
          <a:xfrm>
            <a:off x="6031343" y="890473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i="1" dirty="0"/>
              <a:t>#3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80291C6-07C2-2AF9-3AF7-E4C13B158076}"/>
              </a:ext>
            </a:extLst>
          </p:cNvPr>
          <p:cNvSpPr txBox="1"/>
          <p:nvPr/>
        </p:nvSpPr>
        <p:spPr>
          <a:xfrm>
            <a:off x="6031343" y="2123048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i="1" dirty="0"/>
              <a:t>#2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850C3FE5-1A27-B650-E18B-55211686A235}"/>
              </a:ext>
            </a:extLst>
          </p:cNvPr>
          <p:cNvSpPr txBox="1"/>
          <p:nvPr/>
        </p:nvSpPr>
        <p:spPr>
          <a:xfrm>
            <a:off x="6031343" y="1510979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i="1" dirty="0"/>
              <a:t>#1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3A4E563-E562-6057-80C0-458EDF0B18B2}"/>
              </a:ext>
            </a:extLst>
          </p:cNvPr>
          <p:cNvSpPr txBox="1"/>
          <p:nvPr/>
        </p:nvSpPr>
        <p:spPr>
          <a:xfrm>
            <a:off x="6031343" y="2734370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i="1" dirty="0"/>
              <a:t>#4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B6831DD-CA0E-D3F5-6447-4EA4A0659931}"/>
              </a:ext>
            </a:extLst>
          </p:cNvPr>
          <p:cNvSpPr txBox="1"/>
          <p:nvPr/>
        </p:nvSpPr>
        <p:spPr>
          <a:xfrm>
            <a:off x="3586894" y="475318"/>
            <a:ext cx="12096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err="1"/>
              <a:t>Primary</a:t>
            </a:r>
            <a:r>
              <a:rPr lang="it-IT" sz="1000" dirty="0"/>
              <a:t> tumor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5AED078B-CEB3-4AB1-4347-05135F347035}"/>
              </a:ext>
            </a:extLst>
          </p:cNvPr>
          <p:cNvSpPr txBox="1"/>
          <p:nvPr/>
        </p:nvSpPr>
        <p:spPr>
          <a:xfrm>
            <a:off x="4850950" y="475318"/>
            <a:ext cx="1209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 err="1"/>
              <a:t>Recurrence</a:t>
            </a:r>
            <a:endParaRPr lang="it-IT" sz="1000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4A41CB30-17F6-F333-166B-6FE157E5EF90}"/>
              </a:ext>
            </a:extLst>
          </p:cNvPr>
          <p:cNvSpPr txBox="1"/>
          <p:nvPr/>
        </p:nvSpPr>
        <p:spPr>
          <a:xfrm rot="16200000">
            <a:off x="5932115" y="1491199"/>
            <a:ext cx="1372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TP53 p.P72R VAF (%)</a:t>
            </a:r>
          </a:p>
        </p:txBody>
      </p:sp>
      <p:graphicFrame>
        <p:nvGraphicFramePr>
          <p:cNvPr id="19" name="Oggetto 18">
            <a:extLst>
              <a:ext uri="{FF2B5EF4-FFF2-40B4-BE49-F238E27FC236}">
                <a16:creationId xmlns:a16="http://schemas.microsoft.com/office/drawing/2014/main" id="{C5D9B98F-297C-CA85-08CB-C6CBC79ECF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3691314"/>
              </p:ext>
            </p:extLst>
          </p:nvPr>
        </p:nvGraphicFramePr>
        <p:xfrm>
          <a:off x="6669501" y="757791"/>
          <a:ext cx="2573337" cy="163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117564" imgH="1980869" progId="Prism9.Document">
                  <p:embed/>
                </p:oleObj>
              </mc:Choice>
              <mc:Fallback>
                <p:oleObj name="Prism 9" r:id="rId8" imgW="3117564" imgH="1980869" progId="Prism9.Document">
                  <p:embed/>
                  <p:pic>
                    <p:nvPicPr>
                      <p:cNvPr id="144" name="Oggetto 143">
                        <a:extLst>
                          <a:ext uri="{FF2B5EF4-FFF2-40B4-BE49-F238E27FC236}">
                            <a16:creationId xmlns:a16="http://schemas.microsoft.com/office/drawing/2014/main" id="{3235BBF1-2588-078B-30B1-DFEF4401AE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669501" y="757791"/>
                        <a:ext cx="2573337" cy="163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1" name="Gruppo 50">
            <a:extLst>
              <a:ext uri="{FF2B5EF4-FFF2-40B4-BE49-F238E27FC236}">
                <a16:creationId xmlns:a16="http://schemas.microsoft.com/office/drawing/2014/main" id="{778691FF-29F4-572C-662F-C5FE0ACA6784}"/>
              </a:ext>
            </a:extLst>
          </p:cNvPr>
          <p:cNvGrpSpPr>
            <a:grpSpLocks noChangeAspect="1"/>
          </p:cNvGrpSpPr>
          <p:nvPr/>
        </p:nvGrpSpPr>
        <p:grpSpPr>
          <a:xfrm>
            <a:off x="9415529" y="1420672"/>
            <a:ext cx="1227808" cy="453268"/>
            <a:chOff x="9415534" y="1418137"/>
            <a:chExt cx="1023167" cy="377725"/>
          </a:xfrm>
        </p:grpSpPr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5031D286-241C-D075-BC02-4FD310D46191}"/>
                </a:ext>
              </a:extLst>
            </p:cNvPr>
            <p:cNvSpPr/>
            <p:nvPr/>
          </p:nvSpPr>
          <p:spPr>
            <a:xfrm>
              <a:off x="9415534" y="1481412"/>
              <a:ext cx="72000" cy="72000"/>
            </a:xfrm>
            <a:prstGeom prst="rect">
              <a:avLst/>
            </a:prstGeom>
            <a:pattFill prst="wdDnDiag">
              <a:fgClr>
                <a:srgbClr val="C00000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1" name="Rettangolo 20">
              <a:extLst>
                <a:ext uri="{FF2B5EF4-FFF2-40B4-BE49-F238E27FC236}">
                  <a16:creationId xmlns:a16="http://schemas.microsoft.com/office/drawing/2014/main" id="{3240B73F-AEDA-366E-7AC7-44085FF76407}"/>
                </a:ext>
              </a:extLst>
            </p:cNvPr>
            <p:cNvSpPr/>
            <p:nvPr/>
          </p:nvSpPr>
          <p:spPr>
            <a:xfrm>
              <a:off x="9508879" y="1481412"/>
              <a:ext cx="72000" cy="72000"/>
            </a:xfrm>
            <a:prstGeom prst="rect">
              <a:avLst/>
            </a:prstGeom>
            <a:pattFill prst="wdDnDiag">
              <a:fgClr>
                <a:srgbClr val="0000FF"/>
              </a:fgClr>
              <a:bgClr>
                <a:schemeClr val="bg1"/>
              </a:bgClr>
            </a:patt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2" name="Rettangolo 21">
              <a:extLst>
                <a:ext uri="{FF2B5EF4-FFF2-40B4-BE49-F238E27FC236}">
                  <a16:creationId xmlns:a16="http://schemas.microsoft.com/office/drawing/2014/main" id="{6E07B5ED-C7F2-8F88-DDDE-5F97DA1D42E1}"/>
                </a:ext>
              </a:extLst>
            </p:cNvPr>
            <p:cNvSpPr/>
            <p:nvPr/>
          </p:nvSpPr>
          <p:spPr>
            <a:xfrm>
              <a:off x="9415534" y="1662512"/>
              <a:ext cx="72000" cy="72000"/>
            </a:xfrm>
            <a:prstGeom prst="rect">
              <a:avLst/>
            </a:prstGeom>
            <a:solidFill>
              <a:srgbClr val="C000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" name="Rettangolo 22">
              <a:extLst>
                <a:ext uri="{FF2B5EF4-FFF2-40B4-BE49-F238E27FC236}">
                  <a16:creationId xmlns:a16="http://schemas.microsoft.com/office/drawing/2014/main" id="{B8226D86-0D1B-8863-52EB-41000B832AE8}"/>
                </a:ext>
              </a:extLst>
            </p:cNvPr>
            <p:cNvSpPr/>
            <p:nvPr/>
          </p:nvSpPr>
          <p:spPr>
            <a:xfrm>
              <a:off x="9508879" y="1662512"/>
              <a:ext cx="72000" cy="72000"/>
            </a:xfrm>
            <a:prstGeom prst="rect">
              <a:avLst/>
            </a:prstGeom>
            <a:solidFill>
              <a:srgbClr val="0000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2FCA7AD1-BB86-BBDE-C3FD-5F88A880DCA8}"/>
                </a:ext>
              </a:extLst>
            </p:cNvPr>
            <p:cNvSpPr txBox="1"/>
            <p:nvPr/>
          </p:nvSpPr>
          <p:spPr>
            <a:xfrm>
              <a:off x="9583419" y="1418137"/>
              <a:ext cx="855282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Primary</a:t>
              </a:r>
              <a:r>
                <a:rPr lang="it-IT" sz="900" dirty="0"/>
                <a:t> tumors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5548FF4D-BC94-766D-30D6-0853332CADE6}"/>
                </a:ext>
              </a:extLst>
            </p:cNvPr>
            <p:cNvSpPr txBox="1"/>
            <p:nvPr/>
          </p:nvSpPr>
          <p:spPr>
            <a:xfrm>
              <a:off x="9583419" y="1603502"/>
              <a:ext cx="742060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err="1"/>
                <a:t>Recurrences</a:t>
              </a:r>
              <a:endParaRPr lang="it-IT" sz="900" dirty="0"/>
            </a:p>
          </p:txBody>
        </p:sp>
      </p:grp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C19D419E-ED06-A949-BEC8-FDBE19DBF565}"/>
              </a:ext>
            </a:extLst>
          </p:cNvPr>
          <p:cNvSpPr txBox="1"/>
          <p:nvPr/>
        </p:nvSpPr>
        <p:spPr>
          <a:xfrm>
            <a:off x="2992499" y="322282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85B9A32E-D848-B751-9EA3-1435118E5272}"/>
              </a:ext>
            </a:extLst>
          </p:cNvPr>
          <p:cNvSpPr txBox="1"/>
          <p:nvPr/>
        </p:nvSpPr>
        <p:spPr>
          <a:xfrm>
            <a:off x="7712528" y="1122056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1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83B62966-0951-90F4-121C-E287A7E0E3A0}"/>
              </a:ext>
            </a:extLst>
          </p:cNvPr>
          <p:cNvSpPr txBox="1"/>
          <p:nvPr/>
        </p:nvSpPr>
        <p:spPr>
          <a:xfrm>
            <a:off x="8219860" y="1140344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2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24B34E68-B6D8-8E20-3CFC-D1B55B3B0B4F}"/>
              </a:ext>
            </a:extLst>
          </p:cNvPr>
          <p:cNvSpPr txBox="1"/>
          <p:nvPr/>
        </p:nvSpPr>
        <p:spPr>
          <a:xfrm>
            <a:off x="7168745" y="728618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3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B5EFCC35-484B-606C-35A6-3F7C9301BB31}"/>
              </a:ext>
            </a:extLst>
          </p:cNvPr>
          <p:cNvSpPr txBox="1"/>
          <p:nvPr/>
        </p:nvSpPr>
        <p:spPr>
          <a:xfrm>
            <a:off x="8772828" y="999577"/>
            <a:ext cx="4213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i="1" dirty="0"/>
              <a:t>#4</a:t>
            </a:r>
          </a:p>
        </p:txBody>
      </p:sp>
      <p:pic>
        <p:nvPicPr>
          <p:cNvPr id="38" name="Immagine 37">
            <a:extLst>
              <a:ext uri="{FF2B5EF4-FFF2-40B4-BE49-F238E27FC236}">
                <a16:creationId xmlns:a16="http://schemas.microsoft.com/office/drawing/2014/main" id="{9F50769F-3DAF-5832-C508-C65344CD9B2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50950" y="2580908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Immagine 38">
            <a:extLst>
              <a:ext uri="{FF2B5EF4-FFF2-40B4-BE49-F238E27FC236}">
                <a16:creationId xmlns:a16="http://schemas.microsoft.com/office/drawing/2014/main" id="{AF77BCCB-8232-405A-DC42-B8BE7B0784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86895" y="1960770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Immagine 39">
            <a:extLst>
              <a:ext uri="{FF2B5EF4-FFF2-40B4-BE49-F238E27FC236}">
                <a16:creationId xmlns:a16="http://schemas.microsoft.com/office/drawing/2014/main" id="{FCFEA26D-DCAF-70A4-E0FA-EDE76C3F988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50950" y="1960770"/>
            <a:ext cx="1209600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1" name="Connettore diritto 40">
            <a:extLst>
              <a:ext uri="{FF2B5EF4-FFF2-40B4-BE49-F238E27FC236}">
                <a16:creationId xmlns:a16="http://schemas.microsoft.com/office/drawing/2014/main" id="{9BB7BFAC-EAA9-66E6-40B7-3293A33A3E60}"/>
              </a:ext>
            </a:extLst>
          </p:cNvPr>
          <p:cNvCxnSpPr>
            <a:cxnSpLocks/>
          </p:cNvCxnSpPr>
          <p:nvPr/>
        </p:nvCxnSpPr>
        <p:spPr>
          <a:xfrm>
            <a:off x="7234333" y="2392916"/>
            <a:ext cx="31813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diritto 41">
            <a:extLst>
              <a:ext uri="{FF2B5EF4-FFF2-40B4-BE49-F238E27FC236}">
                <a16:creationId xmlns:a16="http://schemas.microsoft.com/office/drawing/2014/main" id="{58E01758-1CCD-2FC3-73DD-EEFBD0F43891}"/>
              </a:ext>
            </a:extLst>
          </p:cNvPr>
          <p:cNvCxnSpPr>
            <a:cxnSpLocks/>
          </p:cNvCxnSpPr>
          <p:nvPr/>
        </p:nvCxnSpPr>
        <p:spPr>
          <a:xfrm>
            <a:off x="7765868" y="2392916"/>
            <a:ext cx="140648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03F869E6-30B1-49E2-4D1D-77DA7D35C8E8}"/>
              </a:ext>
            </a:extLst>
          </p:cNvPr>
          <p:cNvSpPr txBox="1"/>
          <p:nvPr/>
        </p:nvSpPr>
        <p:spPr>
          <a:xfrm rot="19033658">
            <a:off x="6835244" y="2552669"/>
            <a:ext cx="7420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 err="1"/>
              <a:t>Homozygous</a:t>
            </a:r>
            <a:endParaRPr lang="it-IT" sz="800" dirty="0"/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B643582F-3172-7C9A-4A9C-D5994306168B}"/>
              </a:ext>
            </a:extLst>
          </p:cNvPr>
          <p:cNvSpPr txBox="1"/>
          <p:nvPr/>
        </p:nvSpPr>
        <p:spPr>
          <a:xfrm rot="19033658">
            <a:off x="7872754" y="2574065"/>
            <a:ext cx="8050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800" dirty="0" err="1"/>
              <a:t>Heterozygous</a:t>
            </a:r>
            <a:endParaRPr lang="it-IT" sz="800" dirty="0"/>
          </a:p>
        </p:txBody>
      </p:sp>
      <p:pic>
        <p:nvPicPr>
          <p:cNvPr id="45" name="Immagine 44">
            <a:extLst>
              <a:ext uri="{FF2B5EF4-FFF2-40B4-BE49-F238E27FC236}">
                <a16:creationId xmlns:a16="http://schemas.microsoft.com/office/drawing/2014/main" id="{0819240F-5E80-320A-B9EE-F8FF443A3D8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86894" y="2580908"/>
            <a:ext cx="1196907" cy="5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" name="Connettore 2 3">
            <a:extLst>
              <a:ext uri="{FF2B5EF4-FFF2-40B4-BE49-F238E27FC236}">
                <a16:creationId xmlns:a16="http://schemas.microsoft.com/office/drawing/2014/main" id="{80FE7B2C-40B7-A199-28CE-60AB7B271EA3}"/>
              </a:ext>
            </a:extLst>
          </p:cNvPr>
          <p:cNvCxnSpPr>
            <a:cxnSpLocks/>
          </p:cNvCxnSpPr>
          <p:nvPr/>
        </p:nvCxnSpPr>
        <p:spPr>
          <a:xfrm flipV="1">
            <a:off x="3445339" y="732888"/>
            <a:ext cx="0" cy="2455764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2 45">
            <a:extLst>
              <a:ext uri="{FF2B5EF4-FFF2-40B4-BE49-F238E27FC236}">
                <a16:creationId xmlns:a16="http://schemas.microsoft.com/office/drawing/2014/main" id="{B62CBD03-75AD-1E8E-05B8-E3B2286D0D48}"/>
              </a:ext>
            </a:extLst>
          </p:cNvPr>
          <p:cNvCxnSpPr>
            <a:cxnSpLocks/>
          </p:cNvCxnSpPr>
          <p:nvPr/>
        </p:nvCxnSpPr>
        <p:spPr>
          <a:xfrm>
            <a:off x="3584039" y="3244532"/>
            <a:ext cx="2476511" cy="0"/>
          </a:xfrm>
          <a:prstGeom prst="straightConnector1">
            <a:avLst/>
          </a:prstGeom>
          <a:ln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1A0541E4-A33E-98FD-6FE1-475DFF4EAD7C}"/>
              </a:ext>
            </a:extLst>
          </p:cNvPr>
          <p:cNvSpPr txBox="1"/>
          <p:nvPr/>
        </p:nvSpPr>
        <p:spPr>
          <a:xfrm>
            <a:off x="3584039" y="3250275"/>
            <a:ext cx="2476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VIC </a:t>
            </a:r>
            <a:r>
              <a:rPr lang="it-IT" sz="1000" dirty="0" err="1"/>
              <a:t>fluorescence</a:t>
            </a:r>
            <a:r>
              <a:rPr lang="it-IT" sz="1000" dirty="0"/>
              <a:t> (P allele)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63EC2113-D863-E987-0D76-51FE60E86091}"/>
              </a:ext>
            </a:extLst>
          </p:cNvPr>
          <p:cNvSpPr txBox="1"/>
          <p:nvPr/>
        </p:nvSpPr>
        <p:spPr>
          <a:xfrm rot="16200000">
            <a:off x="2096773" y="1835163"/>
            <a:ext cx="24577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FAM </a:t>
            </a:r>
            <a:r>
              <a:rPr lang="it-IT" sz="1000" dirty="0" err="1"/>
              <a:t>fluorescence</a:t>
            </a:r>
            <a:r>
              <a:rPr lang="it-IT" sz="1000" dirty="0"/>
              <a:t> (R allele)</a:t>
            </a:r>
          </a:p>
        </p:txBody>
      </p:sp>
    </p:spTree>
    <p:extLst>
      <p:ext uri="{BB962C8B-B14F-4D97-AF65-F5344CB8AC3E}">
        <p14:creationId xmlns:p14="http://schemas.microsoft.com/office/powerpoint/2010/main" val="28965969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Widescreen</PresentationFormat>
  <Paragraphs>32</Paragraphs>
  <Slides>1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ism 9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18</cp:revision>
  <cp:lastPrinted>2023-10-12T13:56:18Z</cp:lastPrinted>
  <dcterms:created xsi:type="dcterms:W3CDTF">2022-08-04T15:26:16Z</dcterms:created>
  <dcterms:modified xsi:type="dcterms:W3CDTF">2024-02-13T22:06:42Z</dcterms:modified>
</cp:coreProperties>
</file>